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76" r:id="rId2"/>
    <p:sldId id="277" r:id="rId3"/>
    <p:sldId id="278" r:id="rId4"/>
    <p:sldId id="279" r:id="rId5"/>
    <p:sldId id="272" r:id="rId6"/>
    <p:sldId id="273" r:id="rId7"/>
    <p:sldId id="274" r:id="rId8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o Kawano" userId="50242ba99129fee1" providerId="LiveId" clId="{8CF858E8-3380-475F-AC90-70939A6A35D0}"/>
    <pc:docChg chg="modSld">
      <pc:chgData name="Go Kawano" userId="50242ba99129fee1" providerId="LiveId" clId="{8CF858E8-3380-475F-AC90-70939A6A35D0}" dt="2025-06-08T14:03:37.271" v="19" actId="1037"/>
      <pc:docMkLst>
        <pc:docMk/>
      </pc:docMkLst>
      <pc:sldChg chg="modSp mod">
        <pc:chgData name="Go Kawano" userId="50242ba99129fee1" providerId="LiveId" clId="{8CF858E8-3380-475F-AC90-70939A6A35D0}" dt="2025-06-08T14:03:37.271" v="19" actId="1037"/>
        <pc:sldMkLst>
          <pc:docMk/>
          <pc:sldMk cId="3554500282" sldId="276"/>
        </pc:sldMkLst>
        <pc:spChg chg="mod">
          <ac:chgData name="Go Kawano" userId="50242ba99129fee1" providerId="LiveId" clId="{8CF858E8-3380-475F-AC90-70939A6A35D0}" dt="2025-06-08T14:03:37.271" v="19" actId="1037"/>
          <ac:spMkLst>
            <pc:docMk/>
            <pc:sldMk cId="3554500282" sldId="276"/>
            <ac:spMk id="2" creationId="{23D5BEB8-2472-CECB-A049-2B59E77B29CB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FBF406-8F12-4BB9-9942-C27BDF9CD588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FA17CD-5C8B-4E03-801E-D53F2FA479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39963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033715F-FB39-479B-B44D-513B0410F812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781728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26C9D3-5E2E-01D7-7EA9-B584F1BBC8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D310758-E5BE-FA9A-CE17-5A76417FCAE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C7972B9-81E1-2809-76C9-807A7E9426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CEA96-5EE7-4BAD-A6A1-A631310082CF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0256885-6FE3-94E5-028D-ED78D1FD97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3648A16-6A06-D58B-B9D0-BB962BE0A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262A5-826C-48A6-ACC5-8BF82DC1ED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0591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EDE184-BEA8-194E-C432-E74D4249BC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47B7167-AB68-DC73-010A-1380518390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D53A71F-E9C5-9648-9437-C7822D1846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CEA96-5EE7-4BAD-A6A1-A631310082CF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E0BC1C-6524-8253-4966-304A56858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1318FBC-A9A6-8C1A-BFD0-BFE087F5A2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262A5-826C-48A6-ACC5-8BF82DC1ED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9356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C61BD2D-BF2C-7C88-2FA2-E937DD151C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C473858-FC0C-CFF9-32A1-7566DB02A3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BB51609-3C01-AF24-2331-CD35B0E07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CEA96-5EE7-4BAD-A6A1-A631310082CF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8A319C8-0C18-B1A2-80F2-FD3F83356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1A85514-7C3E-4773-835A-1EB49F5713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262A5-826C-48A6-ACC5-8BF82DC1ED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9319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59B8B8-DDC1-B467-4D4B-0C3E01E112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8EDA301-AC64-47C4-19A4-4A21580D15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A076AED-574C-49B4-3B7C-830934A211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CEA96-5EE7-4BAD-A6A1-A631310082CF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6113252-9174-7BE2-E48F-F4176A1CE5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8CB826E-AEF7-1020-20EF-9C8F6402C8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262A5-826C-48A6-ACC5-8BF82DC1ED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1691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45789A-D753-97F4-1664-A2C1E2D716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9FC512D-A3D4-0B8A-108F-C29835A66F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46F4623-0812-9FF7-9B09-D65FDD0696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CEA96-5EE7-4BAD-A6A1-A631310082CF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72912F8-0352-191B-071D-9A1A876712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AE243C2-5251-1830-EDC6-DD1F751B26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262A5-826C-48A6-ACC5-8BF82DC1ED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93256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ACD1FA4-01ED-19ED-FBD6-3316811951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29B5529-5371-12D8-C598-BA2F9BAC259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D6B230E-C832-7322-DFDA-4052F12F3D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E66770D-5EDE-832F-D137-8BE899C1A8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CEA96-5EE7-4BAD-A6A1-A631310082CF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06CD7D2-F2B6-7ACE-26BE-A60B0445B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4693206-C9CB-E09E-7233-F3E5B51BAC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262A5-826C-48A6-ACC5-8BF82DC1ED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0062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6E72EC-A9C3-1512-112F-30669F135E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E2F0EAE-D97F-24D5-1BFD-F4FAA34D11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0F128BE-3D00-9B53-54AE-A4DC6A7366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CDBD5C4-10A6-3265-04ED-8D89A1C56B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808BC3E-25F9-B72F-38AD-595D347051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7BBAD0A-3D65-135D-C1B3-F95EBDEA5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CEA96-5EE7-4BAD-A6A1-A631310082CF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8026330-631F-C525-5C16-0518BBFE5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43943C1-A529-7DB7-7769-BBE054E808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262A5-826C-48A6-ACC5-8BF82DC1ED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6074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06D108-AF2C-6591-9746-F051AFE3BD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7B0E1D4-820A-7930-0B52-5D9DEB33E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CEA96-5EE7-4BAD-A6A1-A631310082CF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0B6A9AE-3F5D-E4D4-43E1-2BB37A18C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91B6159-AE50-F371-766C-A3019E4E8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262A5-826C-48A6-ACC5-8BF82DC1ED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4706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E7DC2E4-B176-C78F-38E8-382B5C66C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CEA96-5EE7-4BAD-A6A1-A631310082CF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DFD99C9-CC1B-76F2-3CAA-B9DBAFDDFD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626CE3F-8708-0E87-B60D-C1A3C7A81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262A5-826C-48A6-ACC5-8BF82DC1ED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1625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059DED-E54E-3071-E26D-17B825A764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EDD8EF6-EBEE-809A-09BE-6D0A0E73BF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2AE5786-8448-EB59-A241-8B40B5CE91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0B73148-6847-E703-85FC-0413F080EE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CEA96-5EE7-4BAD-A6A1-A631310082CF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0B16CDB-80AC-8DEE-C278-9F2DB45BEC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0E8F8C5-1AA4-92C8-5776-3A35D6F65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262A5-826C-48A6-ACC5-8BF82DC1ED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7021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9C4288-6507-5B46-6EDC-319C417635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E569473-29EC-4A09-65ED-98A18FAB46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056D8C9-9FCC-A5AD-33FF-A648D91D9D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D5536B4-B893-0D27-0F52-DECCF876B8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CEA96-5EE7-4BAD-A6A1-A631310082CF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DA89A7F-282E-3B0A-3EE4-F3A54B604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F1ACA9A-0FB8-FE63-F459-C688EA6609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262A5-826C-48A6-ACC5-8BF82DC1ED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5485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5DF255A-B6EA-6023-23DE-94222C20BA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5B3CF04-EB0D-E104-569D-1F1ED544D2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81822FA-19FE-FA10-8A9F-8BBE8F2EA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CCEA96-5EE7-4BAD-A6A1-A631310082CF}" type="datetimeFigureOut">
              <a:rPr kumimoji="1" lang="ja-JP" altLang="en-US" smtClean="0"/>
              <a:t>2025/6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332576A-9AF9-31B5-3C59-C59AEF3F31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33D85D7-418B-792E-CB83-F3166B4464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8262A5-826C-48A6-ACC5-8BF82DC1ED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2650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C5FC5DFE-E58F-FB22-054F-743CD1BAA4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546" y="1222982"/>
            <a:ext cx="9317419" cy="584077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11664F0-34F5-11B5-5BB0-C0EE50D8EF55}"/>
              </a:ext>
            </a:extLst>
          </p:cNvPr>
          <p:cNvSpPr txBox="1"/>
          <p:nvPr/>
        </p:nvSpPr>
        <p:spPr>
          <a:xfrm>
            <a:off x="2848822" y="6298488"/>
            <a:ext cx="19263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arly-Hypo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2A6B012-CC24-6B70-AE22-785ED8E47422}"/>
              </a:ext>
            </a:extLst>
          </p:cNvPr>
          <p:cNvSpPr txBox="1"/>
          <p:nvPr/>
        </p:nvSpPr>
        <p:spPr>
          <a:xfrm>
            <a:off x="4597310" y="6472348"/>
            <a:ext cx="3694175" cy="41658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5A73D6A-0831-766D-CB40-6090B8DA0AFA}"/>
              </a:ext>
            </a:extLst>
          </p:cNvPr>
          <p:cNvSpPr txBox="1"/>
          <p:nvPr/>
        </p:nvSpPr>
        <p:spPr>
          <a:xfrm>
            <a:off x="2117033" y="1292559"/>
            <a:ext cx="8744447" cy="461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A030934-FFFA-33B5-4A29-177C19123DA6}"/>
              </a:ext>
            </a:extLst>
          </p:cNvPr>
          <p:cNvSpPr txBox="1"/>
          <p:nvPr/>
        </p:nvSpPr>
        <p:spPr>
          <a:xfrm>
            <a:off x="4090417" y="39274"/>
            <a:ext cx="42793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l Fig. 1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4588399-DFC0-BBE9-6D3F-34C6CD2B1FDF}"/>
              </a:ext>
            </a:extLst>
          </p:cNvPr>
          <p:cNvSpPr txBox="1"/>
          <p:nvPr/>
        </p:nvSpPr>
        <p:spPr>
          <a:xfrm>
            <a:off x="5580334" y="6315401"/>
            <a:ext cx="19263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Late-Hypo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1ED9443-CA18-5CEB-C507-59168BBEE027}"/>
              </a:ext>
            </a:extLst>
          </p:cNvPr>
          <p:cNvSpPr txBox="1"/>
          <p:nvPr/>
        </p:nvSpPr>
        <p:spPr>
          <a:xfrm>
            <a:off x="1114094" y="1351319"/>
            <a:ext cx="655529" cy="500957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A6FB7DA-7E66-0466-9999-5375CC0111D4}"/>
              </a:ext>
            </a:extLst>
          </p:cNvPr>
          <p:cNvSpPr txBox="1"/>
          <p:nvPr/>
        </p:nvSpPr>
        <p:spPr>
          <a:xfrm>
            <a:off x="1143514" y="1774992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5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A71C609-9EF4-8177-247C-6766EE6A86D8}"/>
              </a:ext>
            </a:extLst>
          </p:cNvPr>
          <p:cNvSpPr txBox="1"/>
          <p:nvPr/>
        </p:nvSpPr>
        <p:spPr>
          <a:xfrm>
            <a:off x="1143513" y="3164279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0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809CAE6-6683-4B59-05AC-4400D1151E9F}"/>
              </a:ext>
            </a:extLst>
          </p:cNvPr>
          <p:cNvSpPr txBox="1"/>
          <p:nvPr/>
        </p:nvSpPr>
        <p:spPr>
          <a:xfrm>
            <a:off x="1143513" y="4609894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5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C5AE393-6E25-9E25-FE8F-D9456374CC94}"/>
              </a:ext>
            </a:extLst>
          </p:cNvPr>
          <p:cNvSpPr txBox="1"/>
          <p:nvPr/>
        </p:nvSpPr>
        <p:spPr>
          <a:xfrm>
            <a:off x="1143513" y="6010683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B64DA336-A11B-BA05-C4B2-6F112BF5D8AA}"/>
              </a:ext>
            </a:extLst>
          </p:cNvPr>
          <p:cNvCxnSpPr>
            <a:cxnSpLocks/>
          </p:cNvCxnSpPr>
          <p:nvPr/>
        </p:nvCxnSpPr>
        <p:spPr>
          <a:xfrm>
            <a:off x="3581919" y="1010865"/>
            <a:ext cx="0" cy="2584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D5C17449-D508-345C-C578-999264278DBB}"/>
              </a:ext>
            </a:extLst>
          </p:cNvPr>
          <p:cNvCxnSpPr>
            <a:cxnSpLocks/>
          </p:cNvCxnSpPr>
          <p:nvPr/>
        </p:nvCxnSpPr>
        <p:spPr>
          <a:xfrm>
            <a:off x="3571980" y="1511330"/>
            <a:ext cx="246107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5722F290-8316-2343-9210-B55564845F7C}"/>
              </a:ext>
            </a:extLst>
          </p:cNvPr>
          <p:cNvCxnSpPr>
            <a:cxnSpLocks/>
          </p:cNvCxnSpPr>
          <p:nvPr/>
        </p:nvCxnSpPr>
        <p:spPr>
          <a:xfrm>
            <a:off x="6033050" y="1499856"/>
            <a:ext cx="0" cy="2584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3A18EB5C-B2F4-D66E-18B0-349BF79C243E}"/>
              </a:ext>
            </a:extLst>
          </p:cNvPr>
          <p:cNvCxnSpPr>
            <a:cxnSpLocks/>
          </p:cNvCxnSpPr>
          <p:nvPr/>
        </p:nvCxnSpPr>
        <p:spPr>
          <a:xfrm>
            <a:off x="3581397" y="1504127"/>
            <a:ext cx="0" cy="2584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7DA00042-FE72-7929-E081-3C53E6FEAE22}"/>
              </a:ext>
            </a:extLst>
          </p:cNvPr>
          <p:cNvCxnSpPr>
            <a:cxnSpLocks/>
          </p:cNvCxnSpPr>
          <p:nvPr/>
        </p:nvCxnSpPr>
        <p:spPr>
          <a:xfrm>
            <a:off x="3561519" y="1020804"/>
            <a:ext cx="5065643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66803B5E-969A-7C45-CEDC-7CA2DAD0D18E}"/>
              </a:ext>
            </a:extLst>
          </p:cNvPr>
          <p:cNvCxnSpPr>
            <a:cxnSpLocks/>
          </p:cNvCxnSpPr>
          <p:nvPr/>
        </p:nvCxnSpPr>
        <p:spPr>
          <a:xfrm>
            <a:off x="8617223" y="990987"/>
            <a:ext cx="0" cy="2584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12146BA-101A-CACF-D00C-64F2E2480165}"/>
              </a:ext>
            </a:extLst>
          </p:cNvPr>
          <p:cNvSpPr txBox="1"/>
          <p:nvPr/>
        </p:nvSpPr>
        <p:spPr>
          <a:xfrm>
            <a:off x="4101046" y="1112230"/>
            <a:ext cx="192633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ja-JP" sz="24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GB" altLang="ja-JP" sz="2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&lt; 0.001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FDE45DF-7962-7E32-92F9-A3C20D9A1CE1}"/>
              </a:ext>
            </a:extLst>
          </p:cNvPr>
          <p:cNvSpPr txBox="1"/>
          <p:nvPr/>
        </p:nvSpPr>
        <p:spPr>
          <a:xfrm>
            <a:off x="5564350" y="594361"/>
            <a:ext cx="219788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ja-JP" sz="24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GB" altLang="ja-JP" sz="2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= 0.010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D46CEB3-0533-13D7-06E8-3F62A34E045E}"/>
              </a:ext>
            </a:extLst>
          </p:cNvPr>
          <p:cNvSpPr txBox="1"/>
          <p:nvPr/>
        </p:nvSpPr>
        <p:spPr>
          <a:xfrm>
            <a:off x="571640" y="1038316"/>
            <a:ext cx="20505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CS 12</a:t>
            </a:r>
            <a:r>
              <a:rPr lang="en-GB" altLang="ja-JP" sz="2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–</a:t>
            </a: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24 h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0CF1041-DF15-076B-D319-35D2922A40BB}"/>
              </a:ext>
            </a:extLst>
          </p:cNvPr>
          <p:cNvSpPr txBox="1"/>
          <p:nvPr/>
        </p:nvSpPr>
        <p:spPr>
          <a:xfrm>
            <a:off x="8024326" y="6315401"/>
            <a:ext cx="273710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on-Hypo group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3D5BEB8-2472-CECB-A049-2B59E77B29CB}"/>
              </a:ext>
            </a:extLst>
          </p:cNvPr>
          <p:cNvSpPr txBox="1"/>
          <p:nvPr/>
        </p:nvSpPr>
        <p:spPr>
          <a:xfrm>
            <a:off x="4391766" y="5034978"/>
            <a:ext cx="75713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CS12</a:t>
            </a:r>
            <a:r>
              <a:rPr lang="en-GB" altLang="ja-JP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–</a:t>
            </a:r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24</a:t>
            </a:r>
            <a:r>
              <a:rPr lang="ja-JP" altLang="en-US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h of the Early-Hypo group was significantly worse than that </a:t>
            </a:r>
          </a:p>
          <a:p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of the Late-Hypo, or Non-Hypo group </a:t>
            </a:r>
            <a:r>
              <a:rPr lang="en-GB" altLang="ja-JP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</a:t>
            </a:r>
            <a:r>
              <a:rPr lang="en-GB" altLang="ja-JP" sz="18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GB" altLang="ja-JP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&lt; 0.001, </a:t>
            </a:r>
            <a:r>
              <a:rPr lang="en-GB" altLang="ja-JP" sz="18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GB" altLang="ja-JP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= 0.010)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45002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F3F194FE-3BF2-666A-EFD8-ADA7084663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0694" y="133065"/>
            <a:ext cx="10543106" cy="6609111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5FF83F3-2526-5C86-3439-AEAB12543724}"/>
              </a:ext>
            </a:extLst>
          </p:cNvPr>
          <p:cNvSpPr txBox="1"/>
          <p:nvPr/>
        </p:nvSpPr>
        <p:spPr>
          <a:xfrm>
            <a:off x="2560320" y="506841"/>
            <a:ext cx="6778752" cy="461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18E49C7-00FA-034C-D711-E93334EEA0DB}"/>
              </a:ext>
            </a:extLst>
          </p:cNvPr>
          <p:cNvSpPr txBox="1"/>
          <p:nvPr/>
        </p:nvSpPr>
        <p:spPr>
          <a:xfrm>
            <a:off x="4632961" y="6277249"/>
            <a:ext cx="3736848" cy="3064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4233CB3-8866-88F5-9DA6-195FCD3B616B}"/>
              </a:ext>
            </a:extLst>
          </p:cNvPr>
          <p:cNvSpPr txBox="1"/>
          <p:nvPr/>
        </p:nvSpPr>
        <p:spPr>
          <a:xfrm>
            <a:off x="928429" y="1167383"/>
            <a:ext cx="655529" cy="500957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B416E01-52DF-92C5-1C90-61AE24DFB01D}"/>
              </a:ext>
            </a:extLst>
          </p:cNvPr>
          <p:cNvSpPr txBox="1"/>
          <p:nvPr/>
        </p:nvSpPr>
        <p:spPr>
          <a:xfrm>
            <a:off x="2938272" y="5900928"/>
            <a:ext cx="19263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arly-Hypo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806D77C-72F5-686E-AECA-AA935D94AABA}"/>
              </a:ext>
            </a:extLst>
          </p:cNvPr>
          <p:cNvSpPr txBox="1"/>
          <p:nvPr/>
        </p:nvSpPr>
        <p:spPr>
          <a:xfrm>
            <a:off x="8113776" y="5917841"/>
            <a:ext cx="273710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on-Hypo group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46B7EA6-7A7A-533B-0EB9-622428A60DB6}"/>
              </a:ext>
            </a:extLst>
          </p:cNvPr>
          <p:cNvSpPr txBox="1"/>
          <p:nvPr/>
        </p:nvSpPr>
        <p:spPr>
          <a:xfrm>
            <a:off x="5669784" y="5917841"/>
            <a:ext cx="19263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Late-Hypo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4D02465-7CAA-0F78-DF1D-ADBD9FE925DD}"/>
              </a:ext>
            </a:extLst>
          </p:cNvPr>
          <p:cNvSpPr txBox="1"/>
          <p:nvPr/>
        </p:nvSpPr>
        <p:spPr>
          <a:xfrm>
            <a:off x="2023872" y="238617"/>
            <a:ext cx="8400288" cy="461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9D6C3E9-8FF7-075E-6671-3AE9C62210A2}"/>
              </a:ext>
            </a:extLst>
          </p:cNvPr>
          <p:cNvSpPr txBox="1"/>
          <p:nvPr/>
        </p:nvSpPr>
        <p:spPr>
          <a:xfrm>
            <a:off x="4090417" y="58223"/>
            <a:ext cx="42793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l Fig. 2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D69A22C-C1F9-694B-9922-2C7D17B754E6}"/>
              </a:ext>
            </a:extLst>
          </p:cNvPr>
          <p:cNvSpPr txBox="1"/>
          <p:nvPr/>
        </p:nvSpPr>
        <p:spPr>
          <a:xfrm>
            <a:off x="830893" y="1033271"/>
            <a:ext cx="655529" cy="500957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EF3B825-5856-897E-1677-A911A7C64EE6}"/>
              </a:ext>
            </a:extLst>
          </p:cNvPr>
          <p:cNvSpPr txBox="1"/>
          <p:nvPr/>
        </p:nvSpPr>
        <p:spPr>
          <a:xfrm>
            <a:off x="1038157" y="877824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0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8A99990-F37F-6B3E-B5FC-BF9DB97F354C}"/>
              </a:ext>
            </a:extLst>
          </p:cNvPr>
          <p:cNvSpPr txBox="1"/>
          <p:nvPr/>
        </p:nvSpPr>
        <p:spPr>
          <a:xfrm>
            <a:off x="1050348" y="2773680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6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0D73BE3-E8F3-D02D-B0A9-25DAA4DAA9FE}"/>
              </a:ext>
            </a:extLst>
          </p:cNvPr>
          <p:cNvSpPr txBox="1"/>
          <p:nvPr/>
        </p:nvSpPr>
        <p:spPr>
          <a:xfrm>
            <a:off x="1062540" y="3723025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4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37226DB-94BD-1E7F-5501-74E1F0CAF0FC}"/>
              </a:ext>
            </a:extLst>
          </p:cNvPr>
          <p:cNvSpPr txBox="1"/>
          <p:nvPr/>
        </p:nvSpPr>
        <p:spPr>
          <a:xfrm>
            <a:off x="1062539" y="5443300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F6FD140-21C7-83B1-3F60-675BAB0D72E9}"/>
              </a:ext>
            </a:extLst>
          </p:cNvPr>
          <p:cNvSpPr txBox="1"/>
          <p:nvPr/>
        </p:nvSpPr>
        <p:spPr>
          <a:xfrm>
            <a:off x="1056445" y="1822704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9CEA88E-0F13-6319-2B11-55E41FBA9387}"/>
              </a:ext>
            </a:extLst>
          </p:cNvPr>
          <p:cNvSpPr txBox="1"/>
          <p:nvPr/>
        </p:nvSpPr>
        <p:spPr>
          <a:xfrm>
            <a:off x="1068636" y="4582561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2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DBE5E78-906D-0F3B-76AC-DC93D43BE5FA}"/>
              </a:ext>
            </a:extLst>
          </p:cNvPr>
          <p:cNvSpPr txBox="1"/>
          <p:nvPr/>
        </p:nvSpPr>
        <p:spPr>
          <a:xfrm>
            <a:off x="12157" y="238617"/>
            <a:ext cx="16910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ada score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E03F45F-2130-441C-9988-A6DEC2C66459}"/>
              </a:ext>
            </a:extLst>
          </p:cNvPr>
          <p:cNvSpPr txBox="1"/>
          <p:nvPr/>
        </p:nvSpPr>
        <p:spPr>
          <a:xfrm>
            <a:off x="2226362" y="825421"/>
            <a:ext cx="8744447" cy="461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31C8666F-526B-9EA0-8E7F-7D769C9B0A97}"/>
              </a:ext>
            </a:extLst>
          </p:cNvPr>
          <p:cNvCxnSpPr>
            <a:cxnSpLocks/>
          </p:cNvCxnSpPr>
          <p:nvPr/>
        </p:nvCxnSpPr>
        <p:spPr>
          <a:xfrm flipV="1">
            <a:off x="3681309" y="1032718"/>
            <a:ext cx="2769182" cy="1147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331E13C9-C8CD-FC6E-39F6-A1854726D8EF}"/>
              </a:ext>
            </a:extLst>
          </p:cNvPr>
          <p:cNvCxnSpPr>
            <a:cxnSpLocks/>
          </p:cNvCxnSpPr>
          <p:nvPr/>
        </p:nvCxnSpPr>
        <p:spPr>
          <a:xfrm>
            <a:off x="6450491" y="1032718"/>
            <a:ext cx="0" cy="2584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DD310DE3-5A61-6D67-823D-EE8D5289A2F3}"/>
              </a:ext>
            </a:extLst>
          </p:cNvPr>
          <p:cNvCxnSpPr>
            <a:cxnSpLocks/>
          </p:cNvCxnSpPr>
          <p:nvPr/>
        </p:nvCxnSpPr>
        <p:spPr>
          <a:xfrm>
            <a:off x="3690726" y="1036989"/>
            <a:ext cx="0" cy="2584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9A971B0-8476-8D6A-55AA-D95F2A92F153}"/>
              </a:ext>
            </a:extLst>
          </p:cNvPr>
          <p:cNvSpPr txBox="1"/>
          <p:nvPr/>
        </p:nvSpPr>
        <p:spPr>
          <a:xfrm>
            <a:off x="4468789" y="583911"/>
            <a:ext cx="192633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ja-JP" sz="24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GB" altLang="ja-JP" sz="2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GB" altLang="ja-JP" sz="24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= 0.033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2497B67-FFE9-E527-93B3-950D012675F9}"/>
              </a:ext>
            </a:extLst>
          </p:cNvPr>
          <p:cNvSpPr txBox="1"/>
          <p:nvPr/>
        </p:nvSpPr>
        <p:spPr>
          <a:xfrm>
            <a:off x="6661107" y="1186833"/>
            <a:ext cx="55451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ada score of the Early-Hypo group was significantly</a:t>
            </a:r>
          </a:p>
          <a:p>
            <a:r>
              <a:rPr lang="en-GB" altLang="ja-JP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higher than that of the Late-Hypo group (</a:t>
            </a:r>
            <a:r>
              <a:rPr lang="en-GB" altLang="ja-JP" sz="18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GB" altLang="ja-JP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= 0.033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81449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FFF65D9C-6EB9-B624-5535-0944F53DFE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565787"/>
            <a:ext cx="10094843" cy="632811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F5F23BE-90BC-3FB1-5E4F-5D821C3EFEB6}"/>
              </a:ext>
            </a:extLst>
          </p:cNvPr>
          <p:cNvSpPr txBox="1"/>
          <p:nvPr/>
        </p:nvSpPr>
        <p:spPr>
          <a:xfrm>
            <a:off x="2194560" y="92313"/>
            <a:ext cx="8022336" cy="461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A358D8B-BA31-B383-F4A4-CC90EE7EDCC2}"/>
              </a:ext>
            </a:extLst>
          </p:cNvPr>
          <p:cNvSpPr txBox="1"/>
          <p:nvPr/>
        </p:nvSpPr>
        <p:spPr>
          <a:xfrm>
            <a:off x="3572256" y="37151"/>
            <a:ext cx="605942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l Fig. 3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EAAF968-C9CF-9193-E1CA-46B3C7A2AAD6}"/>
              </a:ext>
            </a:extLst>
          </p:cNvPr>
          <p:cNvSpPr txBox="1"/>
          <p:nvPr/>
        </p:nvSpPr>
        <p:spPr>
          <a:xfrm>
            <a:off x="917563" y="1311563"/>
            <a:ext cx="655529" cy="500957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C4E877D-D81C-0B83-7E40-10AF4CD97647}"/>
              </a:ext>
            </a:extLst>
          </p:cNvPr>
          <p:cNvSpPr txBox="1"/>
          <p:nvPr/>
        </p:nvSpPr>
        <p:spPr>
          <a:xfrm>
            <a:off x="840304" y="1247421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4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9DA3423-A108-6DC2-C313-7E3B158055F2}"/>
              </a:ext>
            </a:extLst>
          </p:cNvPr>
          <p:cNvSpPr txBox="1"/>
          <p:nvPr/>
        </p:nvSpPr>
        <p:spPr>
          <a:xfrm>
            <a:off x="852495" y="3504003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2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8236C89-2B6C-BEB7-5210-D98B799742AD}"/>
              </a:ext>
            </a:extLst>
          </p:cNvPr>
          <p:cNvSpPr txBox="1"/>
          <p:nvPr/>
        </p:nvSpPr>
        <p:spPr>
          <a:xfrm>
            <a:off x="864687" y="4659685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05B5CE8-EFD8-BC54-5302-3E389906E6CA}"/>
              </a:ext>
            </a:extLst>
          </p:cNvPr>
          <p:cNvSpPr txBox="1"/>
          <p:nvPr/>
        </p:nvSpPr>
        <p:spPr>
          <a:xfrm>
            <a:off x="858592" y="2358882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3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E11E0D1-3572-885B-9747-A2AE16836EA2}"/>
              </a:ext>
            </a:extLst>
          </p:cNvPr>
          <p:cNvSpPr txBox="1"/>
          <p:nvPr/>
        </p:nvSpPr>
        <p:spPr>
          <a:xfrm>
            <a:off x="876878" y="5779372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F2C9ABA-9635-4340-1655-9A5BB34B1B0A}"/>
              </a:ext>
            </a:extLst>
          </p:cNvPr>
          <p:cNvSpPr txBox="1"/>
          <p:nvPr/>
        </p:nvSpPr>
        <p:spPr>
          <a:xfrm>
            <a:off x="4632961" y="6446212"/>
            <a:ext cx="3736848" cy="3064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9DDAFBE-17EA-05F0-A8A9-3DB537F6F04E}"/>
              </a:ext>
            </a:extLst>
          </p:cNvPr>
          <p:cNvSpPr txBox="1"/>
          <p:nvPr/>
        </p:nvSpPr>
        <p:spPr>
          <a:xfrm>
            <a:off x="2789187" y="6063132"/>
            <a:ext cx="19263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Early-Hypo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93BDE73-A22E-7717-071D-779497DD6144}"/>
              </a:ext>
            </a:extLst>
          </p:cNvPr>
          <p:cNvSpPr txBox="1"/>
          <p:nvPr/>
        </p:nvSpPr>
        <p:spPr>
          <a:xfrm>
            <a:off x="7964691" y="6080045"/>
            <a:ext cx="273710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on-Hypo group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DB7AE5C-234D-0434-D46C-48AB278B198E}"/>
              </a:ext>
            </a:extLst>
          </p:cNvPr>
          <p:cNvSpPr txBox="1"/>
          <p:nvPr/>
        </p:nvSpPr>
        <p:spPr>
          <a:xfrm>
            <a:off x="5520699" y="6080045"/>
            <a:ext cx="19263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Late-Hypo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5BFCD3C-B66D-79C4-536F-5C7D2880CE38}"/>
              </a:ext>
            </a:extLst>
          </p:cNvPr>
          <p:cNvSpPr txBox="1"/>
          <p:nvPr/>
        </p:nvSpPr>
        <p:spPr>
          <a:xfrm>
            <a:off x="-64483" y="163958"/>
            <a:ext cx="281840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CPC at 6 months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fter the onset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E3F7CAC-20B4-4DFB-EC61-580347211525}"/>
              </a:ext>
            </a:extLst>
          </p:cNvPr>
          <p:cNvSpPr txBox="1"/>
          <p:nvPr/>
        </p:nvSpPr>
        <p:spPr>
          <a:xfrm>
            <a:off x="2375452" y="685876"/>
            <a:ext cx="8148097" cy="461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29942B01-187C-9358-F8BB-9C41C87660F4}"/>
              </a:ext>
            </a:extLst>
          </p:cNvPr>
          <p:cNvCxnSpPr>
            <a:cxnSpLocks/>
          </p:cNvCxnSpPr>
          <p:nvPr/>
        </p:nvCxnSpPr>
        <p:spPr>
          <a:xfrm flipV="1">
            <a:off x="3452711" y="953206"/>
            <a:ext cx="2769182" cy="1147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E3F95966-A305-2E54-14E1-F86FA58268C1}"/>
              </a:ext>
            </a:extLst>
          </p:cNvPr>
          <p:cNvCxnSpPr>
            <a:cxnSpLocks/>
          </p:cNvCxnSpPr>
          <p:nvPr/>
        </p:nvCxnSpPr>
        <p:spPr>
          <a:xfrm>
            <a:off x="6221893" y="953206"/>
            <a:ext cx="0" cy="2584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FE80532B-B8BE-BACE-6B19-2DFE78791920}"/>
              </a:ext>
            </a:extLst>
          </p:cNvPr>
          <p:cNvCxnSpPr>
            <a:cxnSpLocks/>
          </p:cNvCxnSpPr>
          <p:nvPr/>
        </p:nvCxnSpPr>
        <p:spPr>
          <a:xfrm>
            <a:off x="3462128" y="957477"/>
            <a:ext cx="0" cy="2584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79A056C-734E-52F8-F00E-87C65BC956BF}"/>
              </a:ext>
            </a:extLst>
          </p:cNvPr>
          <p:cNvSpPr txBox="1"/>
          <p:nvPr/>
        </p:nvSpPr>
        <p:spPr>
          <a:xfrm>
            <a:off x="4240191" y="505283"/>
            <a:ext cx="192633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ja-JP" sz="24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GB" altLang="ja-JP" sz="24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GB" altLang="ja-JP" sz="24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= 0.043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21D216D-AD52-CBF2-7A24-053A00C412DC}"/>
              </a:ext>
            </a:extLst>
          </p:cNvPr>
          <p:cNvSpPr txBox="1"/>
          <p:nvPr/>
        </p:nvSpPr>
        <p:spPr>
          <a:xfrm>
            <a:off x="6999955" y="752379"/>
            <a:ext cx="514756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CPC at 6 months after onset in the Early-Hypo </a:t>
            </a:r>
          </a:p>
          <a:p>
            <a:r>
              <a:rPr lang="en-GB" altLang="ja-JP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roup was significantly worse than that of the </a:t>
            </a:r>
          </a:p>
          <a:p>
            <a:r>
              <a:rPr lang="en-GB" altLang="ja-JP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Late-Hypo group </a:t>
            </a:r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</a:t>
            </a:r>
            <a:r>
              <a:rPr lang="en-GB" altLang="ja-JP" sz="18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GB" altLang="ja-JP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= 0.043)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97295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90B2ECE7-DAC5-3FB0-0D35-D6895CF05B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6957" y="427794"/>
            <a:ext cx="10617087" cy="665548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9179071-CCE7-CC51-F539-683A87F0062A}"/>
              </a:ext>
            </a:extLst>
          </p:cNvPr>
          <p:cNvSpPr txBox="1"/>
          <p:nvPr/>
        </p:nvSpPr>
        <p:spPr>
          <a:xfrm>
            <a:off x="3496452" y="6232094"/>
            <a:ext cx="19263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EE group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3DCE2FB-44E5-048B-48F8-008C3A172BEE}"/>
              </a:ext>
            </a:extLst>
          </p:cNvPr>
          <p:cNvSpPr txBox="1"/>
          <p:nvPr/>
        </p:nvSpPr>
        <p:spPr>
          <a:xfrm>
            <a:off x="7440564" y="6232094"/>
            <a:ext cx="273710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on-PEE group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C54AE46-355F-D79B-F29B-383331A7750B}"/>
              </a:ext>
            </a:extLst>
          </p:cNvPr>
          <p:cNvSpPr txBox="1"/>
          <p:nvPr/>
        </p:nvSpPr>
        <p:spPr>
          <a:xfrm>
            <a:off x="5840496" y="6401551"/>
            <a:ext cx="163982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CB96D5C-F66B-90F6-2F9D-8C9336F5BBBC}"/>
              </a:ext>
            </a:extLst>
          </p:cNvPr>
          <p:cNvSpPr txBox="1"/>
          <p:nvPr/>
        </p:nvSpPr>
        <p:spPr>
          <a:xfrm>
            <a:off x="148141" y="1325879"/>
            <a:ext cx="655529" cy="500957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077B346-92F0-9AFE-25A7-4C76EAA576CB}"/>
              </a:ext>
            </a:extLst>
          </p:cNvPr>
          <p:cNvSpPr txBox="1"/>
          <p:nvPr/>
        </p:nvSpPr>
        <p:spPr>
          <a:xfrm>
            <a:off x="936834" y="1545066"/>
            <a:ext cx="873545" cy="500957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2B34E08-5ABB-9981-A262-2F9E3D026DCF}"/>
              </a:ext>
            </a:extLst>
          </p:cNvPr>
          <p:cNvSpPr txBox="1"/>
          <p:nvPr/>
        </p:nvSpPr>
        <p:spPr>
          <a:xfrm>
            <a:off x="977065" y="1243314"/>
            <a:ext cx="839411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200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4E00C46-0F4F-B26E-D3FD-F912071C48FC}"/>
              </a:ext>
            </a:extLst>
          </p:cNvPr>
          <p:cNvSpPr txBox="1"/>
          <p:nvPr/>
        </p:nvSpPr>
        <p:spPr>
          <a:xfrm>
            <a:off x="989256" y="3541506"/>
            <a:ext cx="82112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00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035DAF8-DB33-F6A5-58E2-2842E7F2B48C}"/>
              </a:ext>
            </a:extLst>
          </p:cNvPr>
          <p:cNvSpPr txBox="1"/>
          <p:nvPr/>
        </p:nvSpPr>
        <p:spPr>
          <a:xfrm>
            <a:off x="1098984" y="4746883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50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AF1A8EB-7D78-A0C9-D9CA-2AEAD6CF4EC9}"/>
              </a:ext>
            </a:extLst>
          </p:cNvPr>
          <p:cNvSpPr txBox="1"/>
          <p:nvPr/>
        </p:nvSpPr>
        <p:spPr>
          <a:xfrm>
            <a:off x="995353" y="2395458"/>
            <a:ext cx="82112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50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3823EE0-3B50-97C9-7E10-5981984F4834}"/>
              </a:ext>
            </a:extLst>
          </p:cNvPr>
          <p:cNvSpPr txBox="1"/>
          <p:nvPr/>
        </p:nvSpPr>
        <p:spPr>
          <a:xfrm>
            <a:off x="1123367" y="5918518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A7CCF64-1B4B-3303-5211-DFF681742C97}"/>
              </a:ext>
            </a:extLst>
          </p:cNvPr>
          <p:cNvSpPr txBox="1"/>
          <p:nvPr/>
        </p:nvSpPr>
        <p:spPr>
          <a:xfrm>
            <a:off x="2194560" y="92313"/>
            <a:ext cx="8022336" cy="461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BBB26B0-6471-040D-586C-18DAF1D699E3}"/>
              </a:ext>
            </a:extLst>
          </p:cNvPr>
          <p:cNvSpPr txBox="1"/>
          <p:nvPr/>
        </p:nvSpPr>
        <p:spPr>
          <a:xfrm>
            <a:off x="-20366" y="52440"/>
            <a:ext cx="278794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Observation period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month)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CC1C7DC-1C6A-79DB-17A1-A672D930AA4A}"/>
              </a:ext>
            </a:extLst>
          </p:cNvPr>
          <p:cNvSpPr txBox="1"/>
          <p:nvPr/>
        </p:nvSpPr>
        <p:spPr>
          <a:xfrm>
            <a:off x="3496452" y="489604"/>
            <a:ext cx="6545910" cy="61755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568E813-7AE3-E66E-FCAD-D9EA658B1C0C}"/>
              </a:ext>
            </a:extLst>
          </p:cNvPr>
          <p:cNvSpPr txBox="1"/>
          <p:nvPr/>
        </p:nvSpPr>
        <p:spPr>
          <a:xfrm>
            <a:off x="3389376" y="100763"/>
            <a:ext cx="605942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l Fig. 4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9B2AFC0-18D0-ABE0-2F55-BBB2B3A12BA1}"/>
              </a:ext>
            </a:extLst>
          </p:cNvPr>
          <p:cNvSpPr txBox="1"/>
          <p:nvPr/>
        </p:nvSpPr>
        <p:spPr>
          <a:xfrm>
            <a:off x="8850907" y="519985"/>
            <a:ext cx="3249608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he observation period of </a:t>
            </a:r>
            <a:r>
              <a:rPr lang="en-GB" altLang="ja-JP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he </a:t>
            </a:r>
          </a:p>
          <a:p>
            <a:r>
              <a:rPr lang="en-GB" altLang="ja-JP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EE and non-PEE</a:t>
            </a:r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</a:p>
          <a:p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roup was median 87 months</a:t>
            </a:r>
          </a:p>
          <a:p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(IQR 38</a:t>
            </a:r>
            <a:r>
              <a:rPr lang="en-GB" altLang="ja-JP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–</a:t>
            </a:r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94.5 months) </a:t>
            </a:r>
          </a:p>
          <a:p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nd 74 months </a:t>
            </a:r>
          </a:p>
          <a:p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IQR 37</a:t>
            </a:r>
            <a:r>
              <a:rPr lang="en-GB" altLang="ja-JP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–</a:t>
            </a:r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108 months), </a:t>
            </a:r>
          </a:p>
          <a:p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respectively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59A72C55-9E23-2829-7C5B-9B68B2022A11}"/>
              </a:ext>
            </a:extLst>
          </p:cNvPr>
          <p:cNvCxnSpPr>
            <a:cxnSpLocks/>
          </p:cNvCxnSpPr>
          <p:nvPr/>
        </p:nvCxnSpPr>
        <p:spPr>
          <a:xfrm>
            <a:off x="4517137" y="1276916"/>
            <a:ext cx="4178935" cy="1147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38B1140D-97C8-DE7B-126E-AC3698BB94F0}"/>
              </a:ext>
            </a:extLst>
          </p:cNvPr>
          <p:cNvCxnSpPr>
            <a:cxnSpLocks/>
          </p:cNvCxnSpPr>
          <p:nvPr/>
        </p:nvCxnSpPr>
        <p:spPr>
          <a:xfrm>
            <a:off x="8696072" y="1276916"/>
            <a:ext cx="0" cy="2584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12DC840E-C4AA-A2AD-2B9B-8CD2EA9B9D3E}"/>
              </a:ext>
            </a:extLst>
          </p:cNvPr>
          <p:cNvCxnSpPr>
            <a:cxnSpLocks/>
          </p:cNvCxnSpPr>
          <p:nvPr/>
        </p:nvCxnSpPr>
        <p:spPr>
          <a:xfrm>
            <a:off x="4524953" y="1281187"/>
            <a:ext cx="0" cy="2584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D40DA54-4540-F015-C2FB-FDEAF931B421}"/>
              </a:ext>
            </a:extLst>
          </p:cNvPr>
          <p:cNvSpPr txBox="1"/>
          <p:nvPr/>
        </p:nvSpPr>
        <p:spPr>
          <a:xfrm>
            <a:off x="6205728" y="682266"/>
            <a:ext cx="8819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86328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8AA499E8-DAFA-D392-372A-688A412696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6093" y="467613"/>
            <a:ext cx="10484285" cy="6572238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0EE8F27-443F-D81A-9393-FDDD765BA60B}"/>
              </a:ext>
            </a:extLst>
          </p:cNvPr>
          <p:cNvSpPr txBox="1"/>
          <p:nvPr/>
        </p:nvSpPr>
        <p:spPr>
          <a:xfrm>
            <a:off x="3389376" y="6171006"/>
            <a:ext cx="19263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EE group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7C1519B-1E25-9B00-592D-C40D4457137D}"/>
              </a:ext>
            </a:extLst>
          </p:cNvPr>
          <p:cNvSpPr txBox="1"/>
          <p:nvPr/>
        </p:nvSpPr>
        <p:spPr>
          <a:xfrm>
            <a:off x="7784592" y="6171006"/>
            <a:ext cx="273710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on-PEE group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EF8D060-A988-19BC-23BE-69D63C9ADA0E}"/>
              </a:ext>
            </a:extLst>
          </p:cNvPr>
          <p:cNvSpPr txBox="1"/>
          <p:nvPr/>
        </p:nvSpPr>
        <p:spPr>
          <a:xfrm>
            <a:off x="391981" y="1266774"/>
            <a:ext cx="658368" cy="45232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3025C56-A39B-8FC9-D6E7-4BFF5E198432}"/>
              </a:ext>
            </a:extLst>
          </p:cNvPr>
          <p:cNvSpPr txBox="1"/>
          <p:nvPr/>
        </p:nvSpPr>
        <p:spPr>
          <a:xfrm>
            <a:off x="708973" y="1172286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5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E4B9308-8B15-3CC5-FB85-5AB72E76D904}"/>
              </a:ext>
            </a:extLst>
          </p:cNvPr>
          <p:cNvSpPr txBox="1"/>
          <p:nvPr/>
        </p:nvSpPr>
        <p:spPr>
          <a:xfrm>
            <a:off x="708972" y="2751150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0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EC0584C-978D-3580-A12C-078119DDA54E}"/>
              </a:ext>
            </a:extLst>
          </p:cNvPr>
          <p:cNvSpPr txBox="1"/>
          <p:nvPr/>
        </p:nvSpPr>
        <p:spPr>
          <a:xfrm>
            <a:off x="708972" y="4285711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5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D942E47-2C80-2575-E6FC-AA638E2024D5}"/>
              </a:ext>
            </a:extLst>
          </p:cNvPr>
          <p:cNvSpPr txBox="1"/>
          <p:nvPr/>
        </p:nvSpPr>
        <p:spPr>
          <a:xfrm>
            <a:off x="708971" y="5932834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83C7D18-FF35-6B96-4052-D4A8A2863179}"/>
              </a:ext>
            </a:extLst>
          </p:cNvPr>
          <p:cNvSpPr txBox="1"/>
          <p:nvPr/>
        </p:nvSpPr>
        <p:spPr>
          <a:xfrm>
            <a:off x="5681472" y="6547327"/>
            <a:ext cx="119481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5865841-E910-C1D1-01C7-9AC7CA329370}"/>
              </a:ext>
            </a:extLst>
          </p:cNvPr>
          <p:cNvSpPr txBox="1"/>
          <p:nvPr/>
        </p:nvSpPr>
        <p:spPr>
          <a:xfrm>
            <a:off x="2560320" y="447735"/>
            <a:ext cx="6778752" cy="461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B8D1666-1C9C-7A4D-C4F0-FE8D5EBBEC25}"/>
              </a:ext>
            </a:extLst>
          </p:cNvPr>
          <p:cNvSpPr txBox="1"/>
          <p:nvPr/>
        </p:nvSpPr>
        <p:spPr>
          <a:xfrm>
            <a:off x="4090417" y="49214"/>
            <a:ext cx="42793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l Fig. 5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FBB4777-8A64-2240-22EF-599C4974545C}"/>
              </a:ext>
            </a:extLst>
          </p:cNvPr>
          <p:cNvSpPr txBox="1"/>
          <p:nvPr/>
        </p:nvSpPr>
        <p:spPr>
          <a:xfrm>
            <a:off x="122440" y="246769"/>
            <a:ext cx="281525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CS 12-24 hours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914F9ADC-EAA8-3E04-7C59-4CFFB88A4141}"/>
              </a:ext>
            </a:extLst>
          </p:cNvPr>
          <p:cNvCxnSpPr>
            <a:cxnSpLocks/>
          </p:cNvCxnSpPr>
          <p:nvPr/>
        </p:nvCxnSpPr>
        <p:spPr>
          <a:xfrm>
            <a:off x="4090417" y="953206"/>
            <a:ext cx="4178935" cy="1147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560F9EDA-2C71-242E-3987-31005863792F}"/>
              </a:ext>
            </a:extLst>
          </p:cNvPr>
          <p:cNvCxnSpPr>
            <a:cxnSpLocks/>
          </p:cNvCxnSpPr>
          <p:nvPr/>
        </p:nvCxnSpPr>
        <p:spPr>
          <a:xfrm>
            <a:off x="8269352" y="953206"/>
            <a:ext cx="0" cy="2584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1A5CE747-A49E-D2E9-A93C-BD17FC146DEA}"/>
              </a:ext>
            </a:extLst>
          </p:cNvPr>
          <p:cNvCxnSpPr>
            <a:cxnSpLocks/>
          </p:cNvCxnSpPr>
          <p:nvPr/>
        </p:nvCxnSpPr>
        <p:spPr>
          <a:xfrm>
            <a:off x="4098233" y="957477"/>
            <a:ext cx="0" cy="2584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6ED395A-2C1A-1719-47DA-36FFCA9EE521}"/>
              </a:ext>
            </a:extLst>
          </p:cNvPr>
          <p:cNvSpPr txBox="1"/>
          <p:nvPr/>
        </p:nvSpPr>
        <p:spPr>
          <a:xfrm>
            <a:off x="5480307" y="446824"/>
            <a:ext cx="192633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ja-JP" sz="28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GB" altLang="ja-JP" sz="2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GB" altLang="ja-JP" sz="28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= 0.006</a:t>
            </a:r>
            <a:endParaRPr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8C2C865-E40D-05EC-A8A6-5ADB892A0D24}"/>
              </a:ext>
            </a:extLst>
          </p:cNvPr>
          <p:cNvSpPr txBox="1"/>
          <p:nvPr/>
        </p:nvSpPr>
        <p:spPr>
          <a:xfrm>
            <a:off x="4981702" y="5034978"/>
            <a:ext cx="65966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CS12-24h of the PEE group was significantly lower than that </a:t>
            </a:r>
          </a:p>
          <a:p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of the non-</a:t>
            </a:r>
            <a:r>
              <a:rPr lang="en-GB" altLang="ja-JP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EE </a:t>
            </a:r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roup </a:t>
            </a:r>
            <a:r>
              <a:rPr lang="en-GB" altLang="ja-JP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</a:t>
            </a:r>
            <a:r>
              <a:rPr lang="en-GB" altLang="ja-JP" sz="18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GB" altLang="ja-JP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= 0.006)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37470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C5146DF9-4D41-BD3C-5C27-FAFD812C62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494186"/>
            <a:ext cx="9939528" cy="6230749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F13172A-3ADC-3939-A6A8-26AFE2780F3F}"/>
              </a:ext>
            </a:extLst>
          </p:cNvPr>
          <p:cNvSpPr txBox="1"/>
          <p:nvPr/>
        </p:nvSpPr>
        <p:spPr>
          <a:xfrm>
            <a:off x="3352800" y="5949696"/>
            <a:ext cx="19263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EE group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1DD337B-CDF8-A667-015E-4F06ECC49986}"/>
              </a:ext>
            </a:extLst>
          </p:cNvPr>
          <p:cNvSpPr txBox="1"/>
          <p:nvPr/>
        </p:nvSpPr>
        <p:spPr>
          <a:xfrm>
            <a:off x="7296912" y="5949696"/>
            <a:ext cx="273710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on-PEE group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B61B3C3-83F2-239E-CBC5-368837732DFC}"/>
              </a:ext>
            </a:extLst>
          </p:cNvPr>
          <p:cNvSpPr txBox="1"/>
          <p:nvPr/>
        </p:nvSpPr>
        <p:spPr>
          <a:xfrm>
            <a:off x="2560320" y="506841"/>
            <a:ext cx="6778752" cy="461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788C1B9-EFA6-1111-0E95-51293DAC23B3}"/>
              </a:ext>
            </a:extLst>
          </p:cNvPr>
          <p:cNvSpPr txBox="1"/>
          <p:nvPr/>
        </p:nvSpPr>
        <p:spPr>
          <a:xfrm>
            <a:off x="5681472" y="6277249"/>
            <a:ext cx="119481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C24AB16-83BF-69F3-0299-8ADA50C6F479}"/>
              </a:ext>
            </a:extLst>
          </p:cNvPr>
          <p:cNvSpPr txBox="1"/>
          <p:nvPr/>
        </p:nvSpPr>
        <p:spPr>
          <a:xfrm>
            <a:off x="4090417" y="66310"/>
            <a:ext cx="42793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l Fig. 6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1B25F06-ED70-9A63-A12F-8CC49A5DF383}"/>
              </a:ext>
            </a:extLst>
          </p:cNvPr>
          <p:cNvSpPr txBox="1"/>
          <p:nvPr/>
        </p:nvSpPr>
        <p:spPr>
          <a:xfrm>
            <a:off x="928429" y="1167383"/>
            <a:ext cx="655529" cy="500957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DA842BD-0732-1FB4-0A5B-81B73DC056E2}"/>
              </a:ext>
            </a:extLst>
          </p:cNvPr>
          <p:cNvSpPr txBox="1"/>
          <p:nvPr/>
        </p:nvSpPr>
        <p:spPr>
          <a:xfrm>
            <a:off x="940621" y="1170432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0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AE57AE0-A758-BC42-5594-3005CFC290BC}"/>
              </a:ext>
            </a:extLst>
          </p:cNvPr>
          <p:cNvSpPr txBox="1"/>
          <p:nvPr/>
        </p:nvSpPr>
        <p:spPr>
          <a:xfrm>
            <a:off x="952812" y="2993136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6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B3C5323-8AE3-48DE-103A-D92545496DC5}"/>
              </a:ext>
            </a:extLst>
          </p:cNvPr>
          <p:cNvSpPr txBox="1"/>
          <p:nvPr/>
        </p:nvSpPr>
        <p:spPr>
          <a:xfrm>
            <a:off x="965004" y="3893713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4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EA2DC1D-A4C1-98A1-763C-827A85CC27BD}"/>
              </a:ext>
            </a:extLst>
          </p:cNvPr>
          <p:cNvSpPr txBox="1"/>
          <p:nvPr/>
        </p:nvSpPr>
        <p:spPr>
          <a:xfrm>
            <a:off x="952811" y="5662756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80528D2-79F1-6C29-F2D0-CEAE8878E6DA}"/>
              </a:ext>
            </a:extLst>
          </p:cNvPr>
          <p:cNvSpPr txBox="1"/>
          <p:nvPr/>
        </p:nvSpPr>
        <p:spPr>
          <a:xfrm>
            <a:off x="958909" y="2054352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BABE4BA-ACEA-64A3-E91D-37F9FCBDBFE8}"/>
              </a:ext>
            </a:extLst>
          </p:cNvPr>
          <p:cNvSpPr txBox="1"/>
          <p:nvPr/>
        </p:nvSpPr>
        <p:spPr>
          <a:xfrm>
            <a:off x="958908" y="4704481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2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4BC4597-59D4-C883-B03B-A0611EE2A738}"/>
              </a:ext>
            </a:extLst>
          </p:cNvPr>
          <p:cNvSpPr txBox="1"/>
          <p:nvPr/>
        </p:nvSpPr>
        <p:spPr>
          <a:xfrm>
            <a:off x="8220" y="447929"/>
            <a:ext cx="16910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ada score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DCB58CE1-5177-D518-7A17-4CBEC7810BA0}"/>
              </a:ext>
            </a:extLst>
          </p:cNvPr>
          <p:cNvCxnSpPr>
            <a:cxnSpLocks/>
          </p:cNvCxnSpPr>
          <p:nvPr/>
        </p:nvCxnSpPr>
        <p:spPr>
          <a:xfrm>
            <a:off x="4189807" y="1142049"/>
            <a:ext cx="4178935" cy="1147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A6DE4DC1-4CC7-F789-C503-E39C66BBE7CE}"/>
              </a:ext>
            </a:extLst>
          </p:cNvPr>
          <p:cNvCxnSpPr>
            <a:cxnSpLocks/>
          </p:cNvCxnSpPr>
          <p:nvPr/>
        </p:nvCxnSpPr>
        <p:spPr>
          <a:xfrm>
            <a:off x="8368742" y="1142049"/>
            <a:ext cx="0" cy="2584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F266D356-F2E8-A49D-81D3-40E2419BC2D7}"/>
              </a:ext>
            </a:extLst>
          </p:cNvPr>
          <p:cNvCxnSpPr>
            <a:cxnSpLocks/>
          </p:cNvCxnSpPr>
          <p:nvPr/>
        </p:nvCxnSpPr>
        <p:spPr>
          <a:xfrm>
            <a:off x="4197623" y="1146320"/>
            <a:ext cx="0" cy="2584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A8C24E1-4055-891D-F609-BE4A33B01143}"/>
              </a:ext>
            </a:extLst>
          </p:cNvPr>
          <p:cNvSpPr txBox="1"/>
          <p:nvPr/>
        </p:nvSpPr>
        <p:spPr>
          <a:xfrm>
            <a:off x="5579697" y="585972"/>
            <a:ext cx="192633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ja-JP" sz="28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GB" altLang="ja-JP" sz="2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GB" altLang="ja-JP" sz="28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= 0.002</a:t>
            </a:r>
            <a:endParaRPr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0B95E16-7CF3-B0CC-9F1A-A1DAD4BC1146}"/>
              </a:ext>
            </a:extLst>
          </p:cNvPr>
          <p:cNvSpPr txBox="1"/>
          <p:nvPr/>
        </p:nvSpPr>
        <p:spPr>
          <a:xfrm>
            <a:off x="5481787" y="1609356"/>
            <a:ext cx="65967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ada score</a:t>
            </a:r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the PEE group was significantly higher than that </a:t>
            </a:r>
          </a:p>
          <a:p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of the non-</a:t>
            </a:r>
            <a:r>
              <a:rPr lang="en-GB" altLang="ja-JP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EE </a:t>
            </a:r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roup </a:t>
            </a:r>
            <a:r>
              <a:rPr lang="en-GB" altLang="ja-JP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</a:t>
            </a:r>
            <a:r>
              <a:rPr lang="en-GB" altLang="ja-JP" sz="18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GB" altLang="ja-JP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= 0.002)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96605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8DA087B7-677C-FD50-2F73-E22A011D1D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8261" y="468330"/>
            <a:ext cx="10455584" cy="6554246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04CC4FB-7AF3-D008-9E44-B7E871AB118B}"/>
              </a:ext>
            </a:extLst>
          </p:cNvPr>
          <p:cNvSpPr txBox="1"/>
          <p:nvPr/>
        </p:nvSpPr>
        <p:spPr>
          <a:xfrm>
            <a:off x="3377184" y="6180945"/>
            <a:ext cx="19263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EE group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952C044-FEDF-E495-4D80-AA5F2A3ECBEB}"/>
              </a:ext>
            </a:extLst>
          </p:cNvPr>
          <p:cNvSpPr txBox="1"/>
          <p:nvPr/>
        </p:nvSpPr>
        <p:spPr>
          <a:xfrm>
            <a:off x="7321296" y="6180945"/>
            <a:ext cx="273710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Non-PEE group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20E7574-5F47-5870-96B3-EB55B3DE6D55}"/>
              </a:ext>
            </a:extLst>
          </p:cNvPr>
          <p:cNvSpPr txBox="1"/>
          <p:nvPr/>
        </p:nvSpPr>
        <p:spPr>
          <a:xfrm>
            <a:off x="2560320" y="445881"/>
            <a:ext cx="6778752" cy="461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425C5EE-F0EF-CB21-17CD-1C3B35844500}"/>
              </a:ext>
            </a:extLst>
          </p:cNvPr>
          <p:cNvSpPr txBox="1"/>
          <p:nvPr/>
        </p:nvSpPr>
        <p:spPr>
          <a:xfrm>
            <a:off x="5681472" y="6459730"/>
            <a:ext cx="119481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B3D08FB-68B2-23B4-624B-30722128C51F}"/>
              </a:ext>
            </a:extLst>
          </p:cNvPr>
          <p:cNvSpPr txBox="1"/>
          <p:nvPr/>
        </p:nvSpPr>
        <p:spPr>
          <a:xfrm>
            <a:off x="3218160" y="55973"/>
            <a:ext cx="609547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l Fig. 7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83F9E3A-DFCD-05E6-ABD6-A8F2634952F8}"/>
              </a:ext>
            </a:extLst>
          </p:cNvPr>
          <p:cNvSpPr txBox="1"/>
          <p:nvPr/>
        </p:nvSpPr>
        <p:spPr>
          <a:xfrm>
            <a:off x="928429" y="1445147"/>
            <a:ext cx="655529" cy="500957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E64E7FC-66A3-BEF4-9C59-633F4ED24782}"/>
              </a:ext>
            </a:extLst>
          </p:cNvPr>
          <p:cNvSpPr txBox="1"/>
          <p:nvPr/>
        </p:nvSpPr>
        <p:spPr>
          <a:xfrm>
            <a:off x="940621" y="1192164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4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6274BB5-C9C7-706E-C21E-A25CFCA211A0}"/>
              </a:ext>
            </a:extLst>
          </p:cNvPr>
          <p:cNvSpPr txBox="1"/>
          <p:nvPr/>
        </p:nvSpPr>
        <p:spPr>
          <a:xfrm>
            <a:off x="952812" y="3490356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2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07031CB-9438-65DD-B610-F1613914F82E}"/>
              </a:ext>
            </a:extLst>
          </p:cNvPr>
          <p:cNvSpPr txBox="1"/>
          <p:nvPr/>
        </p:nvSpPr>
        <p:spPr>
          <a:xfrm>
            <a:off x="965004" y="4646965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9008D8A-6D2C-1EB4-9918-B85CB1FA28AF}"/>
              </a:ext>
            </a:extLst>
          </p:cNvPr>
          <p:cNvSpPr txBox="1"/>
          <p:nvPr/>
        </p:nvSpPr>
        <p:spPr>
          <a:xfrm>
            <a:off x="958909" y="2344308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3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5386299-A729-2E45-8CAF-A5C6987F9E06}"/>
              </a:ext>
            </a:extLst>
          </p:cNvPr>
          <p:cNvSpPr txBox="1"/>
          <p:nvPr/>
        </p:nvSpPr>
        <p:spPr>
          <a:xfrm>
            <a:off x="977195" y="5818600"/>
            <a:ext cx="65552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198B0A3-4B1F-7059-1EF8-9896B049CBC5}"/>
              </a:ext>
            </a:extLst>
          </p:cNvPr>
          <p:cNvSpPr txBox="1"/>
          <p:nvPr/>
        </p:nvSpPr>
        <p:spPr>
          <a:xfrm>
            <a:off x="0" y="107043"/>
            <a:ext cx="281840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CPC at 6 months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fter the onset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82618D43-69A3-B59A-106F-9A10127E8E73}"/>
              </a:ext>
            </a:extLst>
          </p:cNvPr>
          <p:cNvCxnSpPr>
            <a:cxnSpLocks/>
          </p:cNvCxnSpPr>
          <p:nvPr/>
        </p:nvCxnSpPr>
        <p:spPr>
          <a:xfrm>
            <a:off x="4189807" y="913451"/>
            <a:ext cx="4377715" cy="34528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5DF3EB2C-C4FE-E3AE-5578-456F64464176}"/>
              </a:ext>
            </a:extLst>
          </p:cNvPr>
          <p:cNvCxnSpPr>
            <a:cxnSpLocks/>
          </p:cNvCxnSpPr>
          <p:nvPr/>
        </p:nvCxnSpPr>
        <p:spPr>
          <a:xfrm>
            <a:off x="8547644" y="913451"/>
            <a:ext cx="0" cy="2584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4940C8F5-BC18-7B96-B66A-DB59396F2C74}"/>
              </a:ext>
            </a:extLst>
          </p:cNvPr>
          <p:cNvCxnSpPr>
            <a:cxnSpLocks/>
          </p:cNvCxnSpPr>
          <p:nvPr/>
        </p:nvCxnSpPr>
        <p:spPr>
          <a:xfrm>
            <a:off x="4217501" y="897844"/>
            <a:ext cx="0" cy="25841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5B8D69B-6C02-5A78-1015-2B34017CE2C0}"/>
              </a:ext>
            </a:extLst>
          </p:cNvPr>
          <p:cNvSpPr txBox="1"/>
          <p:nvPr/>
        </p:nvSpPr>
        <p:spPr>
          <a:xfrm>
            <a:off x="5619453" y="417008"/>
            <a:ext cx="192633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ja-JP" sz="28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GB" altLang="ja-JP" sz="2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GB" altLang="ja-JP" sz="28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= 0.004</a:t>
            </a:r>
            <a:endParaRPr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2874403-8AF5-0C1F-2E20-18B52E9E5A63}"/>
              </a:ext>
            </a:extLst>
          </p:cNvPr>
          <p:cNvSpPr txBox="1"/>
          <p:nvPr/>
        </p:nvSpPr>
        <p:spPr>
          <a:xfrm>
            <a:off x="3377184" y="5154648"/>
            <a:ext cx="89178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ja-JP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CPC at 6 months after the onset</a:t>
            </a:r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of the PEE group was significantly higher than that </a:t>
            </a:r>
          </a:p>
          <a:p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of the non-</a:t>
            </a:r>
            <a:r>
              <a:rPr lang="en-GB" altLang="ja-JP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EE </a:t>
            </a:r>
            <a:r>
              <a:rPr lang="en-GB" altLang="ja-JP" sz="18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roup </a:t>
            </a:r>
            <a:r>
              <a:rPr lang="en-GB" altLang="ja-JP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</a:t>
            </a:r>
            <a:r>
              <a:rPr lang="en-GB" altLang="ja-JP" sz="18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en-GB" altLang="ja-JP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GB" altLang="ja-JP" sz="1800" kern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= 0.004)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8430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2</TotalTime>
  <Words>313</Words>
  <Application>Microsoft Office PowerPoint</Application>
  <PresentationFormat>ワイド画面</PresentationFormat>
  <Paragraphs>98</Paragraphs>
  <Slides>7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1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o Kawano</dc:creator>
  <cp:lastModifiedBy>Go Kawano</cp:lastModifiedBy>
  <cp:revision>3</cp:revision>
  <dcterms:created xsi:type="dcterms:W3CDTF">2025-04-27T05:00:31Z</dcterms:created>
  <dcterms:modified xsi:type="dcterms:W3CDTF">2025-06-08T14:03:44Z</dcterms:modified>
</cp:coreProperties>
</file>